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336" r:id="rId3"/>
    <p:sldId id="337" r:id="rId4"/>
    <p:sldId id="402" r:id="rId5"/>
    <p:sldId id="403" r:id="rId6"/>
    <p:sldId id="404" r:id="rId7"/>
    <p:sldId id="405" r:id="rId8"/>
    <p:sldId id="406" r:id="rId9"/>
    <p:sldId id="407" r:id="rId10"/>
    <p:sldId id="349" r:id="rId11"/>
    <p:sldId id="364" r:id="rId12"/>
    <p:sldId id="408" r:id="rId13"/>
    <p:sldId id="409" r:id="rId14"/>
    <p:sldId id="410" r:id="rId15"/>
    <p:sldId id="360" r:id="rId16"/>
    <p:sldId id="363" r:id="rId17"/>
    <p:sldId id="357" r:id="rId18"/>
    <p:sldId id="340" r:id="rId19"/>
    <p:sldId id="362" r:id="rId20"/>
    <p:sldId id="346" r:id="rId21"/>
    <p:sldId id="355" r:id="rId22"/>
    <p:sldId id="358" r:id="rId23"/>
    <p:sldId id="353" r:id="rId24"/>
    <p:sldId id="352" r:id="rId25"/>
    <p:sldId id="359" r:id="rId26"/>
    <p:sldId id="373" r:id="rId27"/>
    <p:sldId id="372" r:id="rId28"/>
    <p:sldId id="371" r:id="rId29"/>
    <p:sldId id="370" r:id="rId30"/>
    <p:sldId id="368" r:id="rId31"/>
    <p:sldId id="367" r:id="rId32"/>
    <p:sldId id="369" r:id="rId33"/>
    <p:sldId id="265" r:id="rId34"/>
    <p:sldId id="272" r:id="rId35"/>
    <p:sldId id="376" r:id="rId36"/>
    <p:sldId id="378" r:id="rId37"/>
    <p:sldId id="377" r:id="rId38"/>
    <p:sldId id="375" r:id="rId39"/>
    <p:sldId id="374" r:id="rId40"/>
    <p:sldId id="379" r:id="rId41"/>
    <p:sldId id="262" r:id="rId42"/>
    <p:sldId id="380" r:id="rId43"/>
    <p:sldId id="381" r:id="rId44"/>
    <p:sldId id="382" r:id="rId45"/>
    <p:sldId id="383" r:id="rId46"/>
    <p:sldId id="384" r:id="rId47"/>
    <p:sldId id="385" r:id="rId48"/>
    <p:sldId id="386" r:id="rId49"/>
    <p:sldId id="387" r:id="rId50"/>
    <p:sldId id="388" r:id="rId51"/>
    <p:sldId id="389" r:id="rId52"/>
    <p:sldId id="392" r:id="rId53"/>
    <p:sldId id="390" r:id="rId54"/>
    <p:sldId id="391" r:id="rId55"/>
    <p:sldId id="393" r:id="rId56"/>
    <p:sldId id="395" r:id="rId57"/>
    <p:sldId id="396" r:id="rId58"/>
    <p:sldId id="397" r:id="rId59"/>
    <p:sldId id="398" r:id="rId60"/>
    <p:sldId id="399" r:id="rId61"/>
    <p:sldId id="400" r:id="rId62"/>
    <p:sldId id="401" r:id="rId63"/>
    <p:sldId id="394" r:id="rId64"/>
    <p:sldId id="325" r:id="rId65"/>
    <p:sldId id="324" r:id="rId66"/>
    <p:sldId id="331" r:id="rId67"/>
    <p:sldId id="330" r:id="rId68"/>
    <p:sldId id="263" r:id="rId69"/>
    <p:sldId id="323" r:id="rId70"/>
    <p:sldId id="310" r:id="rId71"/>
    <p:sldId id="298" r:id="rId7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37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6" Type="http://schemas.openxmlformats.org/officeDocument/2006/relationships/tableStyles" Target="tableStyles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8595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8152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748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7295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5174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5481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7375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6547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2923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4195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451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F0FA6-5D2E-4E0A-AD26-C11C65851889}" type="datetimeFigureOut">
              <a:rPr lang="en-AU" smtClean="0"/>
              <a:t>11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E2320-4D1C-41E7-BAC2-1C34FBA80A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1050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69" y="0"/>
            <a:ext cx="12064998" cy="68546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68794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094" y="0"/>
            <a:ext cx="876692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571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590" y="232602"/>
            <a:ext cx="10436485" cy="63927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8351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094" y="0"/>
            <a:ext cx="1050177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72468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467" y="0"/>
            <a:ext cx="782706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325448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1000" y="0"/>
            <a:ext cx="61988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39008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019" y="0"/>
            <a:ext cx="949154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895534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369" y="0"/>
            <a:ext cx="690591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343065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595" y="0"/>
            <a:ext cx="770792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8955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3788" y="0"/>
            <a:ext cx="783971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06756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853" y="0"/>
            <a:ext cx="665629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9605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52" y="0"/>
            <a:ext cx="1208882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160472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910" y="0"/>
            <a:ext cx="576617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824745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4041" y="160866"/>
            <a:ext cx="9220805" cy="6536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30770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1923" y="0"/>
            <a:ext cx="74902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36429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700" y="186266"/>
            <a:ext cx="7712040" cy="6316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57070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4245" y="674531"/>
            <a:ext cx="9828657" cy="5023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22709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840" y="0"/>
            <a:ext cx="102974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363220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1451" y="0"/>
            <a:ext cx="55321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543912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6601" y="0"/>
            <a:ext cx="691746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678648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232" y="0"/>
            <a:ext cx="969940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71710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2613" y="0"/>
            <a:ext cx="908259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6429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4642" y="0"/>
            <a:ext cx="57632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79942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679" y="0"/>
            <a:ext cx="756210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55032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8339" y="0"/>
            <a:ext cx="97915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480211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363" y="0"/>
            <a:ext cx="1180117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873884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2238" y="1912"/>
            <a:ext cx="9550189" cy="68560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242597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976" y="0"/>
            <a:ext cx="48140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6177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969" y="0"/>
            <a:ext cx="77466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37546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952" y="409575"/>
            <a:ext cx="8829675" cy="6038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771677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3827" y="0"/>
            <a:ext cx="862755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597944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437" y="1"/>
            <a:ext cx="1018333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788439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612" y="0"/>
            <a:ext cx="92487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1275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0"/>
            <a:ext cx="10312400" cy="6867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388595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190" y="0"/>
            <a:ext cx="878962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297018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1970" y="0"/>
            <a:ext cx="607890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9130804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973" y="0"/>
            <a:ext cx="69500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953449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9463" y="0"/>
            <a:ext cx="932766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414630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011" y="1"/>
            <a:ext cx="101865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0407819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118" y="0"/>
            <a:ext cx="54989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1708204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494" y="0"/>
            <a:ext cx="749781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556082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3240" y="0"/>
            <a:ext cx="986028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8456119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0758" y="0"/>
            <a:ext cx="674076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9740580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672110"/>
            <a:ext cx="10058400" cy="5359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911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9016" y="0"/>
            <a:ext cx="748788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5819275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697" y="173988"/>
            <a:ext cx="9410700" cy="6200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8732258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4194" y="0"/>
            <a:ext cx="604970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78406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6067" y="0"/>
            <a:ext cx="9761203" cy="6859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947912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19" y="0"/>
            <a:ext cx="828267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38602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5224" y="0"/>
            <a:ext cx="90451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7938877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3566" y="0"/>
            <a:ext cx="60975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4361121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4145" y="0"/>
            <a:ext cx="8410188" cy="6867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9058274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95" y="638175"/>
            <a:ext cx="7296150" cy="5581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8651394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5962" y="671512"/>
            <a:ext cx="8210550" cy="5514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4242290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2200" y="268816"/>
            <a:ext cx="10123153" cy="5979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9624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3765" y="0"/>
            <a:ext cx="739338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7386720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4853" y="0"/>
            <a:ext cx="524861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278783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5470" y="0"/>
            <a:ext cx="642648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832162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187" y="0"/>
            <a:ext cx="56656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6578646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0287" y="0"/>
            <a:ext cx="858818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2054383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9401" y="0"/>
            <a:ext cx="953319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0955154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0149" y="0"/>
            <a:ext cx="907601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395958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525" y="0"/>
            <a:ext cx="1088294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1208773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9813" y="0"/>
            <a:ext cx="982362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7319741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947" y="0"/>
            <a:ext cx="1011836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591974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3239" y="0"/>
            <a:ext cx="536850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52658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412" y="558800"/>
            <a:ext cx="11019176" cy="5401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8543087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45" y="0"/>
            <a:ext cx="55521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1357428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4240" y="0"/>
            <a:ext cx="5420360" cy="6873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03819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4010" y="0"/>
            <a:ext cx="677162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321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153" y="0"/>
            <a:ext cx="1088369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3637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6</TotalTime>
  <Words>0</Words>
  <Application>Microsoft Office PowerPoint</Application>
  <PresentationFormat>Widescreen</PresentationFormat>
  <Paragraphs>0</Paragraphs>
  <Slides>7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1</vt:i4>
      </vt:variant>
    </vt:vector>
  </HeadingPairs>
  <TitlesOfParts>
    <vt:vector size="7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Queens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imalan Rangan</dc:creator>
  <cp:lastModifiedBy>Parimalan Rangan</cp:lastModifiedBy>
  <cp:revision>49</cp:revision>
  <dcterms:created xsi:type="dcterms:W3CDTF">2015-10-12T11:02:11Z</dcterms:created>
  <dcterms:modified xsi:type="dcterms:W3CDTF">2015-11-11T08:08:09Z</dcterms:modified>
</cp:coreProperties>
</file>